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DF0E6A-ED54-47A8-965C-18979E4F8F6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AD7CFF-BFC5-4318-A4A3-EA318AD3AD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8402F-A47F-4A74-885D-E2C0698C0C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04F45B-E197-41D6-9DB1-377CA82D62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8C2099-9AAD-433A-B51F-FDBB2F161C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0D9D43-0852-4263-892B-DD8FF8EAE9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25002-1CF0-4B57-A68F-C57F464576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E529C5-C135-4DF1-8407-50B1077669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50074A-2705-481B-87D7-A963A2E9E5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DA3CDC-0315-48AB-97EA-B1313E7F41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55DD7-FBFE-4EC9-9C56-814FFD02CF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1D4E43-EF2A-4F1F-9BCF-ED943ACA2D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3C348D-58A3-49B2-BCD2-36072379F27B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95280" y="1773360"/>
          <a:ext cx="8137440" cy="4248000"/>
        </p:xfrm>
        <a:graphic>
          <a:graphicData uri="http://schemas.openxmlformats.org/drawingml/2006/table">
            <a:tbl>
              <a:tblPr/>
              <a:tblGrid>
                <a:gridCol w="1627200"/>
                <a:gridCol w="852480"/>
                <a:gridCol w="1008000"/>
                <a:gridCol w="930240"/>
                <a:gridCol w="309600"/>
                <a:gridCol w="1239840"/>
                <a:gridCol w="1085760"/>
                <a:gridCol w="1084320"/>
              </a:tblGrid>
              <a:tr h="4316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rk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ndogeneous respiration rat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nmol O</a:t>
                      </a:r>
                      <a:r>
                        <a:rPr b="1" lang="nn-NO" sz="12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min</a:t>
                      </a:r>
                      <a:r>
                        <a:rPr b="1" lang="nn-NO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(mg dw)</a:t>
                      </a:r>
                      <a:r>
                        <a:rPr b="1" lang="nn-NO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ubstrate-specific respiration rat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nmol O</a:t>
                      </a:r>
                      <a:r>
                        <a:rPr b="1" lang="nn-NO" sz="12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min</a:t>
                      </a:r>
                      <a:r>
                        <a:rPr b="1" lang="nn-NO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(mg dw)</a:t>
                      </a:r>
                      <a:r>
                        <a:rPr b="1" lang="nn-NO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477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eeks of starv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rk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ght (+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ght (-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rk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ght (+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ght (-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352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.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.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2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6.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.0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49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.3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.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.3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.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.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.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532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.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.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.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.0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.1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.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49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.08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.1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1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.45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89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532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7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8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6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8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730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D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ndogeneous respiration rat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nmol O</a:t>
                      </a:r>
                      <a:r>
                        <a:rPr b="1" lang="nn-NO" sz="12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min</a:t>
                      </a:r>
                      <a:r>
                        <a:rPr b="1" lang="nn-NO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(mg dw)</a:t>
                      </a:r>
                      <a:r>
                        <a:rPr b="1" lang="nn-NO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ubstrate-specific respiration rate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nmol O</a:t>
                      </a:r>
                      <a:r>
                        <a:rPr b="1" lang="nn-NO" sz="1200" spc="-1" strike="noStrike" baseline="-25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min</a:t>
                      </a:r>
                      <a:r>
                        <a:rPr b="1" lang="nn-NO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(mg dw)</a:t>
                      </a:r>
                      <a:r>
                        <a:rPr b="1" lang="nn-NO" sz="12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</a:t>
                      </a:r>
                      <a:r>
                        <a:rPr b="1" lang="nn-NO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459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eeks of starv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rk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ght (+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ght (-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rk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ght (+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ight (-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649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6.8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.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.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.3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.8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532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.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6.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.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.6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49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8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.1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.2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.7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532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2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1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1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12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49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4"/>
          <p:cNvSpPr/>
          <p:nvPr/>
        </p:nvSpPr>
        <p:spPr>
          <a:xfrm>
            <a:off x="395280" y="404640"/>
            <a:ext cx="8353440" cy="155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ABLE S3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Endogenous and substrate specific respiration rates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f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Dinoroseobacter shibae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upon starvation under complex media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(Rates were measured in the dark, after switching on light (400 µE m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  <a:ea typeface="Calibri"/>
              </a:rPr>
              <a:t>-2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 s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  <a:ea typeface="Calibri"/>
              </a:rPr>
              <a:t>1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Calibri"/>
              </a:rPr>
              <a:t>) for 2 min, and in the dark again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05T05:21:57Z</dcterms:created>
  <dc:creator>Maya</dc:creator>
  <dc:description/>
  <dc:language>en-US</dc:language>
  <cp:lastModifiedBy>ICBM</cp:lastModifiedBy>
  <dcterms:modified xsi:type="dcterms:W3CDTF">2013-11-22T11:09:47Z</dcterms:modified>
  <cp:revision>2</cp:revision>
  <dc:subject/>
  <dc:title>PowerPoint Presentation</dc:title>
</cp:coreProperties>
</file>